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875"/>
    <p:restoredTop sz="94651"/>
  </p:normalViewPr>
  <p:slideViewPr>
    <p:cSldViewPr snapToGrid="0" snapToObjects="1">
      <p:cViewPr varScale="1">
        <p:scale>
          <a:sx n="76" d="100"/>
          <a:sy n="76" d="100"/>
        </p:scale>
        <p:origin x="321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D0B78-A90D-494E-878E-46B6109C815B}" type="datetimeFigureOut">
              <a:rPr lang="el-GR" smtClean="0"/>
              <a:t>14/12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D46F8-79D6-CF44-8AC1-F702781F241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949582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D0B78-A90D-494E-878E-46B6109C815B}" type="datetimeFigureOut">
              <a:rPr lang="el-GR" smtClean="0"/>
              <a:t>14/12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D46F8-79D6-CF44-8AC1-F702781F241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7787754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D0B78-A90D-494E-878E-46B6109C815B}" type="datetimeFigureOut">
              <a:rPr lang="el-GR" smtClean="0"/>
              <a:t>14/12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D46F8-79D6-CF44-8AC1-F702781F241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0842990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D0B78-A90D-494E-878E-46B6109C815B}" type="datetimeFigureOut">
              <a:rPr lang="el-GR" smtClean="0"/>
              <a:t>14/12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D46F8-79D6-CF44-8AC1-F702781F241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2743624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D0B78-A90D-494E-878E-46B6109C815B}" type="datetimeFigureOut">
              <a:rPr lang="el-GR" smtClean="0"/>
              <a:t>14/12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D46F8-79D6-CF44-8AC1-F702781F241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4400680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D0B78-A90D-494E-878E-46B6109C815B}" type="datetimeFigureOut">
              <a:rPr lang="el-GR" smtClean="0"/>
              <a:t>14/12/2021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D46F8-79D6-CF44-8AC1-F702781F241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7203611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D0B78-A90D-494E-878E-46B6109C815B}" type="datetimeFigureOut">
              <a:rPr lang="el-GR" smtClean="0"/>
              <a:t>14/12/2021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D46F8-79D6-CF44-8AC1-F702781F241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3934607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D0B78-A90D-494E-878E-46B6109C815B}" type="datetimeFigureOut">
              <a:rPr lang="el-GR" smtClean="0"/>
              <a:t>14/12/2021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D46F8-79D6-CF44-8AC1-F702781F241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6205021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D0B78-A90D-494E-878E-46B6109C815B}" type="datetimeFigureOut">
              <a:rPr lang="el-GR" smtClean="0"/>
              <a:t>14/12/2021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D46F8-79D6-CF44-8AC1-F702781F241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4713105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D0B78-A90D-494E-878E-46B6109C815B}" type="datetimeFigureOut">
              <a:rPr lang="el-GR" smtClean="0"/>
              <a:t>14/12/2021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D46F8-79D6-CF44-8AC1-F702781F241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124979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l-GR"/>
              <a:t>Κάντε κλικ στο εικονίδιο για να προσθέσετε εικόνα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D0B78-A90D-494E-878E-46B6109C815B}" type="datetimeFigureOut">
              <a:rPr lang="el-GR" smtClean="0"/>
              <a:t>14/12/2021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D46F8-79D6-CF44-8AC1-F702781F241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136284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FD0B78-A90D-494E-878E-46B6109C815B}" type="datetimeFigureOut">
              <a:rPr lang="el-GR" smtClean="0"/>
              <a:t>14/12/2021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ED46F8-79D6-CF44-8AC1-F702781F241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70791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Εικόνα 4">
            <a:extLst>
              <a:ext uri="{FF2B5EF4-FFF2-40B4-BE49-F238E27FC236}">
                <a16:creationId xmlns:a16="http://schemas.microsoft.com/office/drawing/2014/main" id="{A7654E47-67B5-984B-9364-28039BA18D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3980" y="811304"/>
            <a:ext cx="1906286" cy="1906286"/>
          </a:xfrm>
          <a:prstGeom prst="rect">
            <a:avLst/>
          </a:prstGeom>
        </p:spPr>
      </p:pic>
      <p:pic>
        <p:nvPicPr>
          <p:cNvPr id="7" name="Εικόνα 6">
            <a:extLst>
              <a:ext uri="{FF2B5EF4-FFF2-40B4-BE49-F238E27FC236}">
                <a16:creationId xmlns:a16="http://schemas.microsoft.com/office/drawing/2014/main" id="{279CD442-406C-D04D-B663-5F7873DEB9A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48918" y="811304"/>
            <a:ext cx="1906286" cy="1906286"/>
          </a:xfrm>
          <a:prstGeom prst="rect">
            <a:avLst/>
          </a:prstGeom>
        </p:spPr>
      </p:pic>
      <p:pic>
        <p:nvPicPr>
          <p:cNvPr id="9" name="Εικόνα 8">
            <a:extLst>
              <a:ext uri="{FF2B5EF4-FFF2-40B4-BE49-F238E27FC236}">
                <a16:creationId xmlns:a16="http://schemas.microsoft.com/office/drawing/2014/main" id="{76C5165B-A70B-5146-94D7-7BBC0ABE884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41449" y="811304"/>
            <a:ext cx="1906286" cy="190628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7F2E864-B288-354F-9379-F75F0A0C75CB}"/>
              </a:ext>
            </a:extLst>
          </p:cNvPr>
          <p:cNvSpPr txBox="1"/>
          <p:nvPr/>
        </p:nvSpPr>
        <p:spPr>
          <a:xfrm>
            <a:off x="533980" y="759759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a</a:t>
            </a:r>
            <a:endParaRPr lang="el-GR" dirty="0">
              <a:solidFill>
                <a:schemeClr val="bg1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C9AFC12-9544-6E4B-9866-0A923EA417C0}"/>
              </a:ext>
            </a:extLst>
          </p:cNvPr>
          <p:cNvSpPr txBox="1"/>
          <p:nvPr/>
        </p:nvSpPr>
        <p:spPr>
          <a:xfrm>
            <a:off x="2535839" y="75975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b</a:t>
            </a:r>
            <a:endParaRPr lang="el-GR" dirty="0">
              <a:solidFill>
                <a:schemeClr val="bg1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6576CE2-83B2-CE4D-AFCF-ADDE121D72BF}"/>
              </a:ext>
            </a:extLst>
          </p:cNvPr>
          <p:cNvSpPr txBox="1"/>
          <p:nvPr/>
        </p:nvSpPr>
        <p:spPr>
          <a:xfrm>
            <a:off x="4548918" y="759759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</a:t>
            </a:r>
            <a:endParaRPr lang="el-GR" dirty="0">
              <a:solidFill>
                <a:schemeClr val="bg1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F0B23AA-B58E-AF44-9549-F8046D152E0E}"/>
              </a:ext>
            </a:extLst>
          </p:cNvPr>
          <p:cNvSpPr txBox="1"/>
          <p:nvPr/>
        </p:nvSpPr>
        <p:spPr>
          <a:xfrm>
            <a:off x="4134970" y="127079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1</a:t>
            </a:r>
            <a:endParaRPr lang="el-GR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D6E44D7-53ED-5243-9762-8F53256520CB}"/>
              </a:ext>
            </a:extLst>
          </p:cNvPr>
          <p:cNvSpPr txBox="1"/>
          <p:nvPr/>
        </p:nvSpPr>
        <p:spPr>
          <a:xfrm>
            <a:off x="1900534" y="811304"/>
            <a:ext cx="5453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</a:rPr>
              <a:t>0-25%</a:t>
            </a:r>
            <a:endParaRPr lang="el-GR" sz="1100" dirty="0">
              <a:solidFill>
                <a:schemeClr val="bg1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2FE23C0-8222-4D4A-A43A-CD585B3800B0}"/>
              </a:ext>
            </a:extLst>
          </p:cNvPr>
          <p:cNvSpPr txBox="1"/>
          <p:nvPr/>
        </p:nvSpPr>
        <p:spPr>
          <a:xfrm>
            <a:off x="3880849" y="811304"/>
            <a:ext cx="6174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</a:rPr>
              <a:t>25-50%</a:t>
            </a:r>
            <a:endParaRPr lang="el-GR" sz="1100" dirty="0">
              <a:solidFill>
                <a:schemeClr val="bg1"/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A991B30-386E-3942-8755-1BA5776BD126}"/>
              </a:ext>
            </a:extLst>
          </p:cNvPr>
          <p:cNvSpPr txBox="1"/>
          <p:nvPr/>
        </p:nvSpPr>
        <p:spPr>
          <a:xfrm>
            <a:off x="5881649" y="811304"/>
            <a:ext cx="6174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</a:rPr>
              <a:t>50-75%</a:t>
            </a:r>
            <a:endParaRPr lang="el-GR" sz="1100" dirty="0">
              <a:solidFill>
                <a:schemeClr val="bg1"/>
              </a:solidFill>
            </a:endParaRPr>
          </a:p>
        </p:txBody>
      </p:sp>
      <p:sp>
        <p:nvSpPr>
          <p:cNvPr id="17" name="Ορθογώνιο 16">
            <a:extLst>
              <a:ext uri="{FF2B5EF4-FFF2-40B4-BE49-F238E27FC236}">
                <a16:creationId xmlns:a16="http://schemas.microsoft.com/office/drawing/2014/main" id="{84368596-2167-6049-B4CF-776F66B30FF5}"/>
              </a:ext>
            </a:extLst>
          </p:cNvPr>
          <p:cNvSpPr/>
          <p:nvPr/>
        </p:nvSpPr>
        <p:spPr>
          <a:xfrm>
            <a:off x="681617" y="2893983"/>
            <a:ext cx="567778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ea typeface="Calibri" panose="020F0502020204030204" pitchFamily="34" charset="0"/>
              </a:rPr>
              <a:t>Supplementary Figure 1</a:t>
            </a:r>
            <a:r>
              <a:rPr lang="en-US" sz="1200" dirty="0">
                <a:ea typeface="Calibri" panose="020F0502020204030204" pitchFamily="34" charset="0"/>
              </a:rPr>
              <a:t>: Representative CT images of patients with 0-25% (a), 25-50% (b) and 50-75% (c) CT chest infiltrations </a:t>
            </a:r>
            <a:endParaRPr lang="el-GR" sz="1200" dirty="0"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4528822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Θέμα του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Θέμα του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Θέμα του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41</Words>
  <Application>Microsoft Office PowerPoint</Application>
  <PresentationFormat>Χαρτί Α4 (210x297 χιλ.)</PresentationFormat>
  <Paragraphs>8</Paragraphs>
  <Slides>1</Slides>
  <Notes>0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3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Θέμα του Office</vt:lpstr>
      <vt:lpstr>Παρουσίαση του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Anastasios Kriebardis</dc:creator>
  <cp:lastModifiedBy>akrieb</cp:lastModifiedBy>
  <cp:revision>7</cp:revision>
  <dcterms:created xsi:type="dcterms:W3CDTF">2021-12-09T17:16:13Z</dcterms:created>
  <dcterms:modified xsi:type="dcterms:W3CDTF">2021-12-14T07:35:38Z</dcterms:modified>
</cp:coreProperties>
</file>